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4.png" ContentType="image/png"/>
  <Override PartName="/ppt/media/image1.png" ContentType="image/png"/>
  <Override PartName="/ppt/media/image3.jpeg" ContentType="image/jpeg"/>
  <Override PartName="/ppt/media/image15.png" ContentType="image/png"/>
  <Override PartName="/ppt/media/image2.png" ContentType="image/png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D7706-5E9C-4E11-97AD-D0B04D0985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CB068-4697-4A1B-8D8F-4EF4F68416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2F35E-CFC1-4FD0-BB79-D250D696E0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59C8B-3E0B-486E-94FC-C3BD302EA8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EC0C7-2BA6-4B07-A47D-CF4E5AFFAA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6498A-4266-4088-978D-E058A99125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B3008-1957-47A0-8B72-9999F6967B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6C78B-8997-4F22-861E-9BD767B8F0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8A888-5064-4A94-BD89-8CAAB6B2F7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1C44F-CB0C-44D9-8ADE-29FF01079B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95AF8-6BED-4B03-A1EC-FE5DC088DF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2F521-8678-48EF-883B-6615DEAB6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A43612-6EBF-4CB4-981C-9D55D2B1D5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1.png"/><Relationship Id="rId15" Type="http://schemas.openxmlformats.org/officeDocument/2006/relationships/image" Target="../media/image12.png"/><Relationship Id="rId16" Type="http://schemas.openxmlformats.org/officeDocument/2006/relationships/image" Target="../media/image13.png"/><Relationship Id="rId17" Type="http://schemas.openxmlformats.org/officeDocument/2006/relationships/image" Target="../media/image14.png"/><Relationship Id="rId18" Type="http://schemas.openxmlformats.org/officeDocument/2006/relationships/image" Target="../media/image15.png"/><Relationship Id="rId19" Type="http://schemas.openxmlformats.org/officeDocument/2006/relationships/oleObject" Target="../embeddings/oleObject4.bin"/><Relationship Id="rId20" Type="http://schemas.openxmlformats.org/officeDocument/2006/relationships/image" Target="../media/image16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20" y="2827440"/>
            <a:ext cx="5596560" cy="6318000"/>
            <a:chOff x="2520" y="2827440"/>
            <a:chExt cx="5596560" cy="6318000"/>
          </a:xfrm>
        </p:grpSpPr>
        <p:sp>
          <p:nvSpPr>
            <p:cNvPr id="42" name=""/>
            <p:cNvSpPr/>
            <p:nvPr/>
          </p:nvSpPr>
          <p:spPr>
            <a:xfrm>
              <a:off x="4097520" y="3481560"/>
              <a:ext cx="761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3K9,14a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098960" y="3309840"/>
              <a:ext cx="453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VIN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098960" y="4756320"/>
              <a:ext cx="52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F-Y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098960" y="4340160"/>
              <a:ext cx="52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F-Y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098960" y="4513320"/>
              <a:ext cx="52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NF-Y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97520" y="3819600"/>
              <a:ext cx="767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3K79me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098960" y="3992400"/>
              <a:ext cx="32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97880" y="3649680"/>
              <a:ext cx="703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3K4me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098960" y="4162320"/>
              <a:ext cx="40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2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520" y="8777160"/>
              <a:ext cx="95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Arial"/>
                </a:rPr>
                <a:t>Suppl.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2" name=""/>
            <p:cNvGraphicFramePr/>
            <p:nvPr/>
          </p:nvGraphicFramePr>
          <p:xfrm>
            <a:off x="3422520" y="4567320"/>
            <a:ext cx="630360" cy="1443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422520" y="4567320"/>
                      <a:ext cx="630360" cy="14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4" name=""/>
            <p:cNvGraphicFramePr/>
            <p:nvPr/>
          </p:nvGraphicFramePr>
          <p:xfrm>
            <a:off x="3422520" y="4216320"/>
            <a:ext cx="630360" cy="1447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422520" y="4216320"/>
                      <a:ext cx="630360" cy="144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6" name=""/>
            <p:cNvSpPr/>
            <p:nvPr/>
          </p:nvSpPr>
          <p:spPr>
            <a:xfrm rot="18955200">
              <a:off x="3368880" y="310932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8939000">
              <a:off x="3593880" y="307476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F-Y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8955200">
              <a:off x="3819240" y="311112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Arial"/>
                </a:rPr>
                <a:t>D.N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5">
              <a:lum bright="12000"/>
            </a:blip>
            <a:stretch/>
          </p:blipFill>
          <p:spPr>
            <a:xfrm>
              <a:off x="3422520" y="3363840"/>
              <a:ext cx="630360" cy="1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6"/>
            <a:stretch/>
          </p:blipFill>
          <p:spPr>
            <a:xfrm>
              <a:off x="3422520" y="4394160"/>
              <a:ext cx="630360" cy="1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" descr=""/>
            <p:cNvPicPr/>
            <p:nvPr/>
          </p:nvPicPr>
          <p:blipFill>
            <a:blip r:embed="rId7"/>
            <a:stretch/>
          </p:blipFill>
          <p:spPr>
            <a:xfrm>
              <a:off x="3422520" y="4746600"/>
              <a:ext cx="630360" cy="22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" descr=""/>
            <p:cNvPicPr/>
            <p:nvPr/>
          </p:nvPicPr>
          <p:blipFill>
            <a:blip r:embed="rId8"/>
            <a:stretch/>
          </p:blipFill>
          <p:spPr>
            <a:xfrm>
              <a:off x="3422520" y="3873600"/>
              <a:ext cx="630360" cy="1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9"/>
            <a:stretch/>
          </p:blipFill>
          <p:spPr>
            <a:xfrm>
              <a:off x="3422520" y="4046400"/>
              <a:ext cx="630360" cy="144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" descr=""/>
            <p:cNvPicPr/>
            <p:nvPr/>
          </p:nvPicPr>
          <p:blipFill>
            <a:blip r:embed="rId10"/>
            <a:stretch/>
          </p:blipFill>
          <p:spPr>
            <a:xfrm>
              <a:off x="3422520" y="3703680"/>
              <a:ext cx="630360" cy="14436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65" name=""/>
            <p:cNvGraphicFramePr/>
            <p:nvPr/>
          </p:nvGraphicFramePr>
          <p:xfrm>
            <a:off x="3422520" y="3537000"/>
            <a:ext cx="630360" cy="14436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66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422520" y="3537000"/>
                      <a:ext cx="630360" cy="14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7" name=""/>
            <p:cNvSpPr/>
            <p:nvPr/>
          </p:nvSpPr>
          <p:spPr>
            <a:xfrm>
              <a:off x="3340080" y="3019320"/>
              <a:ext cx="790560" cy="1984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" descr=""/>
            <p:cNvPicPr/>
            <p:nvPr/>
          </p:nvPicPr>
          <p:blipFill>
            <a:blip r:embed="rId13"/>
            <a:srcRect l="49110" t="27724" r="34739" b="70718"/>
            <a:stretch/>
          </p:blipFill>
          <p:spPr>
            <a:xfrm>
              <a:off x="2682720" y="3697200"/>
              <a:ext cx="508320" cy="144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" descr=""/>
            <p:cNvPicPr/>
            <p:nvPr/>
          </p:nvPicPr>
          <p:blipFill>
            <a:blip r:embed="rId14"/>
            <a:srcRect l="69127" t="33541" r="11324" b="60169"/>
            <a:stretch/>
          </p:blipFill>
          <p:spPr>
            <a:xfrm>
              <a:off x="2682720" y="3867120"/>
              <a:ext cx="508320" cy="1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" descr=""/>
            <p:cNvPicPr/>
            <p:nvPr/>
          </p:nvPicPr>
          <p:blipFill>
            <a:blip r:embed="rId15"/>
            <a:srcRect l="61489" t="73462" r="11866" b="19942"/>
            <a:stretch/>
          </p:blipFill>
          <p:spPr>
            <a:xfrm>
              <a:off x="2684520" y="3530520"/>
              <a:ext cx="506520" cy="14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" descr=""/>
            <p:cNvPicPr/>
            <p:nvPr/>
          </p:nvPicPr>
          <p:blipFill>
            <a:blip r:embed="rId16">
              <a:grayscl/>
              <a:lum contrast="18000"/>
            </a:blip>
            <a:srcRect l="48866" t="63209" r="32238" b="24677"/>
            <a:stretch/>
          </p:blipFill>
          <p:spPr>
            <a:xfrm>
              <a:off x="2682720" y="4211640"/>
              <a:ext cx="508320" cy="144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" descr=""/>
            <p:cNvPicPr/>
            <p:nvPr/>
          </p:nvPicPr>
          <p:blipFill>
            <a:blip r:embed="rId17"/>
            <a:srcRect l="35868" t="71131" r="46344" b="20978"/>
            <a:stretch/>
          </p:blipFill>
          <p:spPr>
            <a:xfrm>
              <a:off x="2682720" y="4041720"/>
              <a:ext cx="508320" cy="14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"/>
            <p:cNvSpPr/>
            <p:nvPr/>
          </p:nvSpPr>
          <p:spPr>
            <a:xfrm rot="18955200">
              <a:off x="2662200" y="310284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8955200">
              <a:off x="2937960" y="3104640"/>
              <a:ext cx="38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Arial"/>
                </a:rPr>
                <a:t>D.N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5" name="" descr=""/>
            <p:cNvPicPr/>
            <p:nvPr/>
          </p:nvPicPr>
          <p:blipFill>
            <a:blip r:embed="rId18"/>
            <a:srcRect l="35868" t="71131" r="46344" b="20978"/>
            <a:stretch/>
          </p:blipFill>
          <p:spPr>
            <a:xfrm>
              <a:off x="2682720" y="3357720"/>
              <a:ext cx="508320" cy="14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"/>
            <p:cNvSpPr/>
            <p:nvPr/>
          </p:nvSpPr>
          <p:spPr>
            <a:xfrm>
              <a:off x="2631960" y="3009960"/>
              <a:ext cx="631800" cy="1565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478320" y="2827440"/>
              <a:ext cx="53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IH3T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659680" y="2827440"/>
              <a:ext cx="55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CT1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9" name=""/>
            <p:cNvGraphicFramePr/>
            <p:nvPr/>
          </p:nvGraphicFramePr>
          <p:xfrm>
            <a:off x="2682720" y="4389480"/>
            <a:ext cx="508320" cy="144360"/>
          </p:xfrm>
          <a:graphic>
            <a:graphicData uri="http://schemas.openxmlformats.org/presentationml/2006/ole">
              <p:oleObj r:id="rId19" spid="">
                <p:embed/>
                <p:pic>
                  <p:nvPicPr>
                    <p:cNvPr id="80" name="" descr=""/>
                    <p:cNvPicPr/>
                    <p:nvPr/>
                  </p:nvPicPr>
                  <p:blipFill>
                    <a:blip r:embed="rId20"/>
                    <a:stretch/>
                  </p:blipFill>
                  <p:spPr>
                    <a:xfrm>
                      <a:off x="2682720" y="4389480"/>
                      <a:ext cx="508320" cy="14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1" name=""/>
            <p:cNvSpPr/>
            <p:nvPr/>
          </p:nvSpPr>
          <p:spPr>
            <a:xfrm>
              <a:off x="2144160" y="4319640"/>
              <a:ext cx="380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YA 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44520" y="4446720"/>
              <a:ext cx="40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YA 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489040" y="4432320"/>
              <a:ext cx="133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2482920" y="4495680"/>
              <a:ext cx="13968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287360" y="6002280"/>
              <a:ext cx="4311720" cy="1736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upplementary 2.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estern blot analysis of extracts of cells infected with GFP, Ad-NF-YA and Ad-YA-DN, with antibodies against NF-YA, NF-YB, NF-YC, and the indicated histone modifications. Left Panels, HCT116; Right Panels, NIH3T3. YA l and YA s refer to the two splicing isoforms of NF-YA: note that HCT116 mainly express the short isoform and that Ad vectors express the long isoform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1T15:31:01Z</dcterms:created>
  <dc:creator>raffaella</dc:creator>
  <dc:description/>
  <dc:language>en-US</dc:language>
  <cp:lastModifiedBy>ROBERTO</cp:lastModifiedBy>
  <dcterms:modified xsi:type="dcterms:W3CDTF">2008-02-07T17:16:51Z</dcterms:modified>
  <cp:revision>16</cp:revision>
  <dc:subject/>
  <dc:title>Diapositiva 1</dc:title>
</cp:coreProperties>
</file>